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48"/>
    <p:restoredTop sz="94694"/>
  </p:normalViewPr>
  <p:slideViewPr>
    <p:cSldViewPr snapToGrid="0" snapToObjects="1">
      <p:cViewPr varScale="1">
        <p:scale>
          <a:sx n="109" d="100"/>
          <a:sy n="109" d="100"/>
        </p:scale>
        <p:origin x="426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527DE2-DB16-6D47-BE9A-E773CE0E30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CC9D8E-D8F9-954A-914E-F1498042F9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64AE2C-DB47-784B-9B92-CFDEC8BEA3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3EA086-443D-C045-936D-4146F229EA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015EC0-4E31-DA4E-AB45-6D9F2F7553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3186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D55D29-7620-9442-8F4D-E3D1F11351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5F818E1-AB14-4E43-8F27-3AAC438DDB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D500BA-7458-F946-BB56-F58F4A1D1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BC9F83-5876-BE40-AC39-173B47995A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AF67D4-F05D-9F4D-B4ED-90F8179FF6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00972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8DAC48C-85D6-A743-8630-17BA937E4D1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904370-F140-B240-B35F-556A776181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62C634-7AA3-CD41-94AF-60A1C87D04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FAA9F2-2447-604E-88AF-4B939010D5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DF2EF2-26DE-3C45-8FA0-BED25E90B5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538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4D8C47-44C4-AF40-87CF-1CB6B3B734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5C7D65-9496-F74B-8FEF-6DEBD7823C0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42F37D-E2E6-F24E-A70F-A3D4B647A0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411FE5-E2F4-E548-8D57-CE5C4CA761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D32E67-B0DC-674B-A9B6-7E8AF1E59A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304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0DAF29-F2E2-1D42-99B2-7868FEE6BA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426678-39C4-AE44-8320-2B1F52334D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791EA0-86BB-0B44-904C-35609E143B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8BDE37-932D-6F44-9F2B-4277DB2D09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651804-1EC2-B445-A44E-79AFE43397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7391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01D582-E72F-3B45-AD26-023A8DA231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C640C1-D8F5-A049-8C4C-D7A7BF97785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7F288B9-5E66-5741-8C73-4D316CD633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E04A38-CF59-4B45-AC47-969972AE55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269D8B-5793-E74D-A2D0-88357A2CCB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C26180-0E0A-C24B-BF08-E217CD045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2322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108F83-AF9A-7447-A53F-C798AF0A88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C7EAD5-D857-D345-8349-3E8ED8FE48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EC18BC-79E5-BF4A-B179-73C58CF1E4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F78AC38-A6DA-9B47-93AE-E4B6859ABC9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BA2C28F-B920-5C4D-A810-EE5548CB94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3F691DB-9269-044D-80F8-F0F96F1881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A2DC709-1787-B14A-B689-8B7DA8C5D0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10B7C92-B68F-F743-B385-24F6D98550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0226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2734CB-6EEA-254F-AFD4-2DC4D99DAE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4776F4D-B1F0-994D-BD8D-B24AFDBE0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1CCD26E-3EB3-BE4C-A819-D334DA3779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EE60354-ADD1-E94D-87D8-E72FC18A00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303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0A2A80F-705B-314E-AA16-B9B16697D4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751B19A-DAED-A04D-B72B-156C95F622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FE9304E-C7FD-D54A-ADF2-2BCE71AA48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2811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53C74A-1AA6-B44A-A5FF-64154B5DC5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D97BAE-5556-F44B-A210-05CD9883DF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B0E2088-FB2C-6B48-8030-A40AAACE4D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700CA0-0AA0-654F-A4AB-72267B17A0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FF78B6-8CE9-B548-9262-1C7AFEBB2F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8A8E99-B9C5-0C46-A2C9-D22B59C901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828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517526-456F-A746-BE6A-7E75671FB0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993BCAC-BD78-7546-BBB7-55A115FBAD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3061C3-BC8E-C245-8534-3C98C49A95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97E667-DF22-C44F-B331-0884390B1D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9468B9-846C-9E4F-B9CC-FD9D70ABCB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7A57CD-35DF-FF48-99FD-B1EF179389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027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78AF500-205F-DA4A-839B-9F719C2626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B9FC47-D673-6D4A-AB17-C0B59ACABC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5DF2BE-2E1D-1047-B444-6C082E19BC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096239-11CE-4643-BC49-16BE878176E4}" type="datetimeFigureOut">
              <a:rPr lang="en-US" smtClean="0"/>
              <a:t>9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CAB571-7AAE-CA4D-86D2-195630DCDEB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A6C815-B746-724E-BAC5-BEA851A405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7BFA6F-723A-E74E-9FF7-69FB69289B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7001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22288" y="5947978"/>
            <a:ext cx="119238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2</a:t>
            </a:r>
            <a:r>
              <a:rPr lang="en-US" sz="1200" dirty="0" smtClean="0"/>
              <a:t>. Contamination signals for IPA using blank extraction with two different pipette tips. A</a:t>
            </a:r>
            <a:r>
              <a:rPr lang="en-AU" sz="1200" dirty="0" smtClean="0"/>
              <a:t>) Molecular signals are identical to IPA with both of MRM transitions in blank extraction </a:t>
            </a:r>
            <a:r>
              <a:rPr lang="en-AU" sz="1200" dirty="0"/>
              <a:t>with </a:t>
            </a:r>
            <a:r>
              <a:rPr lang="en-AU" sz="1200" dirty="0" err="1"/>
              <a:t>Interpath</a:t>
            </a:r>
            <a:r>
              <a:rPr lang="en-AU" sz="1200" dirty="0"/>
              <a:t> </a:t>
            </a:r>
            <a:r>
              <a:rPr lang="en-AU" sz="1200" dirty="0" smtClean="0"/>
              <a:t>services pipette tips.  B) No signals are detectable for </a:t>
            </a:r>
            <a:r>
              <a:rPr lang="en-AU" sz="1200" dirty="0"/>
              <a:t>IPA </a:t>
            </a:r>
            <a:r>
              <a:rPr lang="en-AU" sz="1200" dirty="0" smtClean="0"/>
              <a:t>in blank extraction with Vertex pipette tips.</a:t>
            </a:r>
            <a:endParaRPr lang="en-AU" sz="1200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2" cstate="print"/>
          <a:srcRect l="11176" t="11876" r="63040" b="14909"/>
          <a:stretch/>
        </p:blipFill>
        <p:spPr bwMode="auto">
          <a:xfrm>
            <a:off x="1457591" y="340153"/>
            <a:ext cx="3527768" cy="56347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 rotWithShape="1">
          <a:blip r:embed="rId2" cstate="print"/>
          <a:srcRect l="71499" t="12220" r="1103" b="14820"/>
          <a:stretch/>
        </p:blipFill>
        <p:spPr bwMode="auto">
          <a:xfrm>
            <a:off x="5556540" y="337108"/>
            <a:ext cx="3763643" cy="56378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" name="TextBox 9"/>
          <p:cNvSpPr txBox="1"/>
          <p:nvPr/>
        </p:nvSpPr>
        <p:spPr>
          <a:xfrm>
            <a:off x="1678842" y="0"/>
            <a:ext cx="30752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Interpath services pipette tips</a:t>
            </a:r>
            <a:endParaRPr lang="en-AU" dirty="0"/>
          </a:p>
        </p:txBody>
      </p:sp>
      <p:sp>
        <p:nvSpPr>
          <p:cNvPr id="11" name="TextBox 10"/>
          <p:cNvSpPr txBox="1"/>
          <p:nvPr/>
        </p:nvSpPr>
        <p:spPr>
          <a:xfrm>
            <a:off x="5900730" y="15389"/>
            <a:ext cx="30752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Vertex pipette tips</a:t>
            </a:r>
            <a:endParaRPr lang="en-AU" dirty="0"/>
          </a:p>
        </p:txBody>
      </p:sp>
      <p:sp>
        <p:nvSpPr>
          <p:cNvPr id="5" name="TextBox 4"/>
          <p:cNvSpPr txBox="1"/>
          <p:nvPr/>
        </p:nvSpPr>
        <p:spPr>
          <a:xfrm>
            <a:off x="823630" y="0"/>
            <a:ext cx="41335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000" b="1" dirty="0" smtClean="0"/>
              <a:t>A</a:t>
            </a:r>
            <a:endParaRPr lang="en-AU" sz="20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5166371" y="-15389"/>
            <a:ext cx="41335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000" b="1" dirty="0" smtClean="0"/>
              <a:t>B</a:t>
            </a:r>
            <a:endParaRPr lang="en-AU" sz="2000" b="1" dirty="0"/>
          </a:p>
        </p:txBody>
      </p:sp>
    </p:spTree>
    <p:extLst>
      <p:ext uri="{BB962C8B-B14F-4D97-AF65-F5344CB8AC3E}">
        <p14:creationId xmlns:p14="http://schemas.microsoft.com/office/powerpoint/2010/main" val="28421380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6</TotalTime>
  <Words>64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 Cao</dc:creator>
  <cp:lastModifiedBy>Da Cao</cp:lastModifiedBy>
  <cp:revision>17</cp:revision>
  <dcterms:created xsi:type="dcterms:W3CDTF">2020-04-04T08:00:48Z</dcterms:created>
  <dcterms:modified xsi:type="dcterms:W3CDTF">2020-09-11T04:41:30Z</dcterms:modified>
</cp:coreProperties>
</file>